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71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01991B-B377-6C6B-F0AA-924BAD9CD35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0F543B1-7455-C7E6-2121-120385F0C24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637818-B90C-94BD-B476-F758CB4640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19E8B-E2E8-4AED-B643-3C005DD4BDA7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C633DF-CAC0-E701-27C7-4C3816F70C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C1283A-70A8-9963-9753-AE73F53EBB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E8DED-3A0A-434F-A23D-5BE1C7AB5E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37033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7B23F8-E863-AA09-DDAF-C4455AB8AC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A615145-3E7B-A939-C605-2B603688E1B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5DD3A1-EACB-301D-E081-27A5C00CCD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19E8B-E2E8-4AED-B643-3C005DD4BDA7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27DE4C-5745-B9EC-51ED-0A87E5295D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633894-8975-EC47-7FCB-FECBE14C5B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E8DED-3A0A-434F-A23D-5BE1C7AB5E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21992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3F3A23F-4E9B-CF64-525A-57A31D21C4E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748389C-5121-C221-6700-A8F90A1B81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8ACCB6-E305-1823-8652-F9CEC4FEEA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19E8B-E2E8-4AED-B643-3C005DD4BDA7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94A87F-D852-105E-08C0-86CD972689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2D3A30-102C-162D-C2EF-4CF06791CE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E8DED-3A0A-434F-A23D-5BE1C7AB5E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00473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0D861D-17E4-8B99-82DC-E2BF10683D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E8C9FB-FAFF-8921-60E4-9BBFCE96F49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B4B80E-2649-C97A-ACBB-A9BD66D384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19E8B-E2E8-4AED-B643-3C005DD4BDA7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7F796A-6F70-4151-0DA7-F23EB08D35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A744A6-0D85-6E00-DF46-DF60619576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E8DED-3A0A-434F-A23D-5BE1C7AB5E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53458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AFF5FA-FEB2-429D-D82E-5EFB75AC2D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407A8CC-F4C0-0781-B24A-19E6B94ED7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0298DF-6581-6D51-829D-FFFB4CD034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19E8B-E2E8-4AED-B643-3C005DD4BDA7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C69322-3100-BA9C-CC27-F89CD6C18E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9414E4-9919-DD55-7CC7-BA5FFD0B4B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E8DED-3A0A-434F-A23D-5BE1C7AB5E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238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EF8E3F-D337-AF5A-CFFA-3323C57CA9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22A2CF0-79FE-102F-357D-23CD676E935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540DED4-65A4-ED9B-4BF2-3E315BD0BC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9420D0-72C6-A021-6324-40CF131665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19E8B-E2E8-4AED-B643-3C005DD4BDA7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54F5FFC-9B18-1564-86C3-BB0E61769A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A63DA49-13E6-E0EE-9A70-C3E1F2625F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E8DED-3A0A-434F-A23D-5BE1C7AB5E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12083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F408B3-DCE5-9F60-5951-E039FF84FD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1329CCA-B5D9-B604-9805-C1CCEBC374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CB54492-2EAB-E867-0376-C4C2756F52E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C97357C-2669-0C8F-55ED-52FAAA73179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825309C-DCFF-025C-7B32-DC73A397025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6542428-568A-331E-08F7-1DFE5864E6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19E8B-E2E8-4AED-B643-3C005DD4BDA7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44FFFB3-A1D7-654C-1DC8-427B5AA96D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91A7C54-4228-4DD8-1BF7-B0E701F4C2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E8DED-3A0A-434F-A23D-5BE1C7AB5E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03417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28CCCF-8EF5-04AA-B5DF-080CA0E1CA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DB0D8FE-5F7A-02B7-4D5C-010F368AEB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19E8B-E2E8-4AED-B643-3C005DD4BDA7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6387DB2-9A73-AC25-68DC-E70DE33665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DD19B4B-8BE3-4B43-7FD5-D2F5DB671B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E8DED-3A0A-434F-A23D-5BE1C7AB5E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65165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D63F061-1A53-C8B9-1774-E2A2C8ABA8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19E8B-E2E8-4AED-B643-3C005DD4BDA7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A4ECF44-2F0D-C828-5E51-C7A1CCE020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DCCEBF9-7674-0DC0-11D5-9AD64F0357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E8DED-3A0A-434F-A23D-5BE1C7AB5E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3058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0BFA37-0143-FDB6-16E3-541AA2F735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A20BC8-7358-A618-C275-A8968837DD2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A2ADDCB-890F-C70C-20B9-9CB10E2A2F9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1D4D05E-9EDA-D251-FBA6-E0B9947FC9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19E8B-E2E8-4AED-B643-3C005DD4BDA7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6252022-F6FA-B64D-01D9-6E736B1629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E8F18F-0AE9-8362-6378-6C0858E4E2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E8DED-3A0A-434F-A23D-5BE1C7AB5E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84892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719F40-BC83-9F92-F6C8-8CB2FE6F07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323929B-DE74-121C-952F-C3704A08984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E749F0C-ECB9-9D2B-ECDB-A79874FE67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3A4AF2-220D-F3C8-67A8-B932891DA0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19E8B-E2E8-4AED-B643-3C005DD4BDA7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247386-9819-4330-7E63-89C0E00F0C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D16F0A9-0A80-7540-4750-F91E32F389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E8DED-3A0A-434F-A23D-5BE1C7AB5E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5371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6271888-72B2-2708-8266-894C7B69D7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12AFE1D-AF2D-FEBA-3C9B-E2E7BB1F3E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B88405-E093-A699-E3F7-5EECBBFE31A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419E8B-E2E8-4AED-B643-3C005DD4BDA7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053A59-B910-BB0E-973E-658B174BE7B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89443C-C4CE-A738-8C44-32B88DEF101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8E8DED-3A0A-434F-A23D-5BE1C7AB5E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50029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>
            <a:extLst>
              <a:ext uri="{FF2B5EF4-FFF2-40B4-BE49-F238E27FC236}">
                <a16:creationId xmlns:a16="http://schemas.microsoft.com/office/drawing/2014/main" id="{028B2FE0-2A03-40DC-AB8E-22E520A5EEFB}"/>
              </a:ext>
            </a:extLst>
          </p:cNvPr>
          <p:cNvSpPr txBox="1"/>
          <p:nvPr/>
        </p:nvSpPr>
        <p:spPr>
          <a:xfrm>
            <a:off x="6263522" y="109838"/>
            <a:ext cx="2857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7B6FAB3-740E-498D-A7E8-373E464A14B1}"/>
              </a:ext>
            </a:extLst>
          </p:cNvPr>
          <p:cNvSpPr txBox="1"/>
          <p:nvPr/>
        </p:nvSpPr>
        <p:spPr>
          <a:xfrm>
            <a:off x="3155358" y="102781"/>
            <a:ext cx="2857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2513648-EA2A-3A2D-168C-1CB9745812A1}"/>
              </a:ext>
            </a:extLst>
          </p:cNvPr>
          <p:cNvSpPr txBox="1"/>
          <p:nvPr/>
        </p:nvSpPr>
        <p:spPr>
          <a:xfrm>
            <a:off x="3155359" y="2267431"/>
            <a:ext cx="6262018" cy="93871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100" b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</a:rPr>
              <a:t>Fig. S2</a:t>
            </a:r>
            <a:r>
              <a:rPr lang="en-US" sz="1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</a:rPr>
              <a:t> Real-time PCR was performed using RNA samples from EV, 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</a:rPr>
              <a:t>FaWRKY29</a:t>
            </a:r>
            <a:r>
              <a:rPr lang="en-US" sz="1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</a:rPr>
              <a:t>-RNAi fruits and 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</a:rPr>
              <a:t>FaWRKY64</a:t>
            </a:r>
            <a:r>
              <a:rPr lang="en-US" sz="1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</a:rPr>
              <a:t>-RNAi fruits collected zero days and four days after 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</a:rPr>
              <a:t>Botrytis cinerea</a:t>
            </a:r>
            <a:r>
              <a:rPr lang="en-US" sz="1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</a:rPr>
              <a:t> inoculation. (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</a:rPr>
              <a:t>A</a:t>
            </a:r>
            <a:r>
              <a:rPr lang="en-US" sz="1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</a:rPr>
              <a:t>) Relative expression of 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</a:rPr>
              <a:t>FaWRKY29.</a:t>
            </a:r>
            <a:r>
              <a:rPr lang="en-US" sz="1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</a:rPr>
              <a:t> (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</a:rPr>
              <a:t>B) </a:t>
            </a:r>
            <a:r>
              <a:rPr lang="en-US" sz="1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</a:rPr>
              <a:t>Relative expression of 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</a:rPr>
              <a:t>FaWRKY64. </a:t>
            </a:r>
            <a:r>
              <a:rPr lang="en-US" sz="1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</a:rPr>
              <a:t>Three biological replicates and three technical replicates were applied. Asterisks indicate significant differences from the EV at zero days determined by the Student’s t-test (* p &lt; 0.05, ** p &lt; 0.01) </a:t>
            </a:r>
            <a:endParaRPr lang="en-US" sz="1100" dirty="0"/>
          </a:p>
        </p:txBody>
      </p:sp>
      <p:pic>
        <p:nvPicPr>
          <p:cNvPr id="7" name="그림 6">
            <a:extLst>
              <a:ext uri="{FF2B5EF4-FFF2-40B4-BE49-F238E27FC236}">
                <a16:creationId xmlns:a16="http://schemas.microsoft.com/office/drawing/2014/main" id="{25F8E519-249F-40F1-B940-5E7445E34AA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84" t="31549" r="18875" b="48552"/>
          <a:stretch/>
        </p:blipFill>
        <p:spPr>
          <a:xfrm>
            <a:off x="3220741" y="332229"/>
            <a:ext cx="6102897" cy="19226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43588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8</TotalTime>
  <Words>82</Words>
  <Application>Microsoft Office PowerPoint</Application>
  <PresentationFormat>와이드스크린</PresentationFormat>
  <Paragraphs>3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Malgun Gothic</vt:lpstr>
      <vt:lpstr>Arial</vt:lpstr>
      <vt:lpstr>Calibri</vt:lpstr>
      <vt:lpstr>Calibri Light</vt:lpstr>
      <vt:lpstr>Times New Roman</vt:lpstr>
      <vt:lpstr>Office Theme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만보 이</dc:creator>
  <cp:lastModifiedBy>이만보</cp:lastModifiedBy>
  <cp:revision>7</cp:revision>
  <dcterms:created xsi:type="dcterms:W3CDTF">2023-08-11T10:33:06Z</dcterms:created>
  <dcterms:modified xsi:type="dcterms:W3CDTF">2023-09-01T07:52:02Z</dcterms:modified>
</cp:coreProperties>
</file>